
<file path=[Content_Types].xml><?xml version="1.0" encoding="utf-8"?>
<Types xmlns="http://schemas.openxmlformats.org/package/2006/content-types">
  <Default Extension="emf" ContentType="image/x-emf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>
        <p15:guide id="2" pos="2591" userDrawn="1">
          <p15:clr>
            <a:srgbClr val="A4A3A4"/>
          </p15:clr>
        </p15:guide>
        <p15:guide id="4" orient="horz" pos="136" userDrawn="1">
          <p15:clr>
            <a:srgbClr val="A4A3A4"/>
          </p15:clr>
        </p15:guide>
        <p15:guide id="5" orient="horz" pos="1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767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horzBarState="maximized">
    <p:restoredLeft sz="15625"/>
    <p:restoredTop sz="94674"/>
  </p:normalViewPr>
  <p:slideViewPr>
    <p:cSldViewPr snapToGrid="0" snapToObjects="1" showGuides="1">
      <p:cViewPr>
        <p:scale>
          <a:sx n="66" d="100"/>
          <a:sy n="66" d="100"/>
        </p:scale>
        <p:origin x="-1936" y="80"/>
      </p:cViewPr>
      <p:guideLst>
        <p:guide orient="horz" pos="136"/>
        <p:guide orient="horz" pos="113"/>
        <p:guide pos="259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820970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946437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13384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4294807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75044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524415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19916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67086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02618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789972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44450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BFDC-2EF1-2C4E-8D9D-0DD09BB77531}" type="datetimeFigureOut">
              <a:rPr lang="fr-FR" smtClean="0"/>
              <a:pPr/>
              <a:t>3/04/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79E1F-DA04-9E4C-8D5E-AADA6233C28D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56919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e 22">
            <a:extLst>
              <a:ext uri="{FF2B5EF4-FFF2-40B4-BE49-F238E27FC236}">
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E5ED1F7-B7A0-4A47-8BAA-877B58EFD902}"/>
              </a:ext>
            </a:extLst>
          </p:cNvPr>
          <p:cNvGrpSpPr/>
          <p:nvPr/>
        </p:nvGrpSpPr>
        <p:grpSpPr>
          <a:xfrm>
            <a:off x="151486" y="787449"/>
            <a:ext cx="6527748" cy="7748429"/>
            <a:chOff x="151486" y="787449"/>
            <a:chExt cx="6527748" cy="7748429"/>
          </a:xfrm>
        </p:grpSpPr>
        <p:grpSp>
          <p:nvGrpSpPr>
            <p:cNvPr id="22" name="Groupe 21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8F8671-873A-784E-8859-3C70A955A785}"/>
                </a:ext>
              </a:extLst>
            </p:cNvPr>
            <p:cNvGrpSpPr/>
            <p:nvPr/>
          </p:nvGrpSpPr>
          <p:grpSpPr>
            <a:xfrm>
              <a:off x="507860" y="787449"/>
              <a:ext cx="5839257" cy="7029096"/>
              <a:chOff x="507860" y="787449"/>
              <a:chExt cx="5839257" cy="7029096"/>
            </a:xfrm>
          </p:grpSpPr>
          <p:grpSp>
            <p:nvGrpSpPr>
              <p:cNvPr id="14" name="Groupe 13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3BF0B9-B7B0-2644-85DB-3E2CAC76FCDE}"/>
                  </a:ext>
                </a:extLst>
              </p:cNvPr>
              <p:cNvGrpSpPr/>
              <p:nvPr/>
            </p:nvGrpSpPr>
            <p:grpSpPr>
              <a:xfrm>
                <a:off x="507860" y="787449"/>
                <a:ext cx="4186632" cy="1224944"/>
                <a:chOff x="507860" y="787449"/>
                <a:chExt cx="4186632" cy="1224944"/>
              </a:xfrm>
            </p:grpSpPr>
            <p:grpSp>
              <p:nvGrpSpPr>
                <p:cNvPr id="6" name="Groupe 5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5D37878-2141-6A4E-B07E-9C2853EC5CCC}"/>
                    </a:ext>
                  </a:extLst>
                </p:cNvPr>
                <p:cNvGrpSpPr/>
                <p:nvPr/>
              </p:nvGrpSpPr>
              <p:grpSpPr>
                <a:xfrm>
                  <a:off x="2203935" y="908472"/>
                  <a:ext cx="2490557" cy="1103921"/>
                  <a:chOff x="1829713" y="1150816"/>
                  <a:chExt cx="2490557" cy="1103921"/>
                </a:xfrm>
              </p:grpSpPr>
              <p:sp>
                <p:nvSpPr>
                  <p:cNvPr id="99" name="TextBox 11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D7C645-7D19-1240-95BF-72B39FCE3BD4}"/>
                      </a:ext>
                    </a:extLst>
                  </p:cNvPr>
                  <p:cNvSpPr txBox="1"/>
                  <p:nvPr/>
                </p:nvSpPr>
                <p:spPr>
                  <a:xfrm>
                    <a:off x="3112731" y="1150816"/>
                    <a:ext cx="657444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18600</a:t>
                    </a:r>
                  </a:p>
                </p:txBody>
              </p:sp>
              <p:grpSp>
                <p:nvGrpSpPr>
                  <p:cNvPr id="134" name="Grouper 26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7A60EB8-0F34-8747-9F3A-7A64B0A11445}"/>
                      </a:ext>
                    </a:extLst>
                  </p:cNvPr>
                  <p:cNvGrpSpPr/>
                  <p:nvPr/>
                </p:nvGrpSpPr>
                <p:grpSpPr>
                  <a:xfrm>
                    <a:off x="1946252" y="1573075"/>
                    <a:ext cx="2195992" cy="288000"/>
                    <a:chOff x="7777851" y="39913299"/>
                    <a:chExt cx="2195992" cy="288000"/>
                  </a:xfrm>
                </p:grpSpPr>
                <p:cxnSp>
                  <p:nvCxnSpPr>
                    <p:cNvPr id="137" name="Straight Connector 9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A2A3A77-73AD-C144-8896-6DC20324FD3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7777851" y="40055735"/>
                      <a:ext cx="2195992" cy="3127"/>
                    </a:xfrm>
                    <a:prstGeom prst="line">
                      <a:avLst/>
                    </a:prstGeom>
                    <a:ln>
                      <a:headEnd type="none" w="med" len="med"/>
                      <a:tailEnd type="none" w="med" len="med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74" name="Down Arrow 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8A93771-700D-BA4B-BFC3-10FBFEB26697}"/>
                        </a:ext>
                      </a:extLst>
                    </p:cNvPr>
                    <p:cNvSpPr>
                      <a:spLocks noChangeAspect="1"/>
                    </p:cNvSpPr>
                    <p:nvPr/>
                  </p:nvSpPr>
                  <p:spPr>
                    <a:xfrm rot="16200000">
                      <a:off x="9125415" y="39865151"/>
                      <a:ext cx="259273" cy="384294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75" name="Down Arrow 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E9BCB0E-13C1-684A-95BD-DEF7711D3AE1}"/>
                        </a:ext>
                      </a:extLst>
                    </p:cNvPr>
                    <p:cNvSpPr>
                      <a:spLocks noChangeAspect="1"/>
                    </p:cNvSpPr>
                    <p:nvPr/>
                  </p:nvSpPr>
                  <p:spPr>
                    <a:xfrm rot="16200000">
                      <a:off x="8793926" y="39865151"/>
                      <a:ext cx="259273" cy="384294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76" name="Down Arrow 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37EDB67-53D3-5740-972A-4DD9FEB487CC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 rot="5400000" flipH="1">
                      <a:off x="9648288" y="39967300"/>
                      <a:ext cx="288000" cy="179997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177" name="Down Arrow 8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6F8BA3-25D5-2D4D-BB3E-378F57FAFD97}"/>
                        </a:ext>
                      </a:extLst>
                    </p:cNvPr>
                    <p:cNvSpPr>
                      <a:spLocks/>
                    </p:cNvSpPr>
                    <p:nvPr/>
                  </p:nvSpPr>
                  <p:spPr>
                    <a:xfrm rot="5400000" flipH="1">
                      <a:off x="7859323" y="39967300"/>
                      <a:ext cx="288000" cy="179997"/>
                    </a:xfrm>
                    <a:prstGeom prst="downArrow">
                      <a:avLst>
                        <a:gd name="adj1" fmla="val 56250"/>
                        <a:gd name="adj2" fmla="val 50000"/>
                      </a:avLst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vert="vert270" rtlCol="0" anchor="ctr"/>
                    <a:lstStyle/>
                    <a:p>
                      <a:pPr algn="ctr"/>
                      <a:endParaRPr lang="en-US" sz="1400">
                        <a:latin typeface="Arial"/>
                        <a:cs typeface="Arial"/>
                      </a:endParaRPr>
                    </a:p>
                  </p:txBody>
                </p:sp>
              </p:grpSp>
              <p:sp>
                <p:nvSpPr>
                  <p:cNvPr id="178" name="TextBox 11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5E0995D-68A4-6A40-816B-B5A84D121BB4}"/>
                      </a:ext>
                    </a:extLst>
                  </p:cNvPr>
                  <p:cNvSpPr txBox="1"/>
                  <p:nvPr/>
                </p:nvSpPr>
                <p:spPr>
                  <a:xfrm>
                    <a:off x="2591243" y="1259260"/>
                    <a:ext cx="667526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18595</a:t>
                    </a:r>
                  </a:p>
                </p:txBody>
              </p:sp>
              <p:sp>
                <p:nvSpPr>
                  <p:cNvPr id="181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9B6EAB5-C4C6-3346-AB97-8801BF3E89D5}"/>
                      </a:ext>
                    </a:extLst>
                  </p:cNvPr>
                  <p:cNvSpPr txBox="1"/>
                  <p:nvPr/>
                </p:nvSpPr>
                <p:spPr>
                  <a:xfrm>
                    <a:off x="3598666" y="1727549"/>
                    <a:ext cx="255770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/>
                        <a:cs typeface="Arial"/>
                      </a:rPr>
                      <a:t>89</a:t>
                    </a:r>
                  </a:p>
                </p:txBody>
              </p:sp>
              <p:sp>
                <p:nvSpPr>
                  <p:cNvPr id="182" name="TextBox 25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D69463E-E4F8-3543-955B-0FD80B512F5C}"/>
                      </a:ext>
                    </a:extLst>
                  </p:cNvPr>
                  <p:cNvSpPr txBox="1"/>
                  <p:nvPr/>
                </p:nvSpPr>
                <p:spPr>
                  <a:xfrm>
                    <a:off x="2352103" y="1727549"/>
                    <a:ext cx="351664" cy="138499"/>
                  </a:xfrm>
                  <a:prstGeom prst="rect">
                    <a:avLst/>
                  </a:prstGeom>
                  <a:noFill/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latin typeface="Arial"/>
                        <a:cs typeface="Arial"/>
                      </a:rPr>
                      <a:t>421</a:t>
                    </a:r>
                  </a:p>
                </p:txBody>
              </p:sp>
              <p:sp>
                <p:nvSpPr>
                  <p:cNvPr id="183" name="TextBox 10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B62A75-7EF9-F74C-B351-B249F9FD08C7}"/>
                      </a:ext>
                    </a:extLst>
                  </p:cNvPr>
                  <p:cNvSpPr txBox="1"/>
                  <p:nvPr/>
                </p:nvSpPr>
                <p:spPr>
                  <a:xfrm>
                    <a:off x="1829713" y="1212216"/>
                    <a:ext cx="732090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EPIMA_CII0182</a:t>
                    </a:r>
                  </a:p>
                </p:txBody>
              </p:sp>
              <p:sp>
                <p:nvSpPr>
                  <p:cNvPr id="184" name="TextBox 3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4F353A-8966-F74C-9C73-D334814E6AEF}"/>
                      </a:ext>
                    </a:extLst>
                  </p:cNvPr>
                  <p:cNvSpPr txBox="1"/>
                  <p:nvPr/>
                </p:nvSpPr>
                <p:spPr>
                  <a:xfrm>
                    <a:off x="3673332" y="1205120"/>
                    <a:ext cx="64693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LIMLP</a:t>
                    </a:r>
                  </a:p>
                  <a:p>
                    <a:pPr algn="ctr"/>
                    <a:r>
                      <a:rPr lang="en-US" sz="900" b="1" dirty="0">
                        <a:solidFill>
                          <a:srgbClr val="000000"/>
                        </a:solidFill>
                        <a:latin typeface="Arial"/>
                        <a:cs typeface="Arial"/>
                      </a:rPr>
                      <a:t>_18605</a:t>
                    </a:r>
                  </a:p>
                </p:txBody>
              </p:sp>
              <p:grpSp>
                <p:nvGrpSpPr>
                  <p:cNvPr id="185" name="Grouper 69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7329020-737D-6946-8E94-8CF3E3FBC20E}"/>
                      </a:ext>
                    </a:extLst>
                  </p:cNvPr>
                  <p:cNvGrpSpPr/>
                  <p:nvPr/>
                </p:nvGrpSpPr>
                <p:grpSpPr>
                  <a:xfrm>
                    <a:off x="2636033" y="1863336"/>
                    <a:ext cx="431999" cy="291243"/>
                    <a:chOff x="1270029" y="2816023"/>
                    <a:chExt cx="431999" cy="291243"/>
                  </a:xfrm>
                </p:grpSpPr>
                <p:sp>
                  <p:nvSpPr>
                    <p:cNvPr id="19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933CDFA-2304-6141-A561-7DF7928557B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40828" y="2844797"/>
                      <a:ext cx="218174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p:txBody>
                </p:sp>
                <p:sp>
                  <p:nvSpPr>
                    <p:cNvPr id="19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29C9AF4-224C-2E42-A38B-5DE9F6CF1B4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90752" y="2968767"/>
                      <a:ext cx="318327" cy="1384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350)</a:t>
                      </a:r>
                    </a:p>
                  </p:txBody>
                </p:sp>
                <p:cxnSp>
                  <p:nvCxnSpPr>
                    <p:cNvPr id="200" name="Connecteur droit 19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A62AD16-C98A-E04E-8F8B-7ACBE745775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270029" y="2816023"/>
                      <a:ext cx="431999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01" name="Grouper 7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281B24-50A2-4C48-8A82-CDEB78FB2856}"/>
                      </a:ext>
                    </a:extLst>
                  </p:cNvPr>
                  <p:cNvGrpSpPr/>
                  <p:nvPr/>
                </p:nvGrpSpPr>
                <p:grpSpPr>
                  <a:xfrm>
                    <a:off x="3041138" y="1963494"/>
                    <a:ext cx="359997" cy="291243"/>
                    <a:chOff x="1270030" y="2816023"/>
                    <a:chExt cx="359997" cy="291243"/>
                  </a:xfrm>
                </p:grpSpPr>
                <p:sp>
                  <p:nvSpPr>
                    <p:cNvPr id="20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CEFE00B-EA33-934D-BE93-7FD1CA1B1B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40828" y="2844797"/>
                      <a:ext cx="218174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p:txBody>
                </p:sp>
                <p:sp>
                  <p:nvSpPr>
                    <p:cNvPr id="203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534B49C-BF64-324D-A0EF-A4067730BC6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90752" y="2968767"/>
                      <a:ext cx="318327" cy="1384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265)</a:t>
                      </a:r>
                    </a:p>
                  </p:txBody>
                </p:sp>
                <p:cxnSp>
                  <p:nvCxnSpPr>
                    <p:cNvPr id="204" name="Connecteur droit 20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99D84D4-E5C2-5C4C-BB2E-E01D8525799C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270030" y="2816023"/>
                      <a:ext cx="359997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05" name="Grouper 7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5874815-DAB5-9E47-9219-D6037E192395}"/>
                      </a:ext>
                    </a:extLst>
                  </p:cNvPr>
                  <p:cNvGrpSpPr/>
                  <p:nvPr/>
                </p:nvGrpSpPr>
                <p:grpSpPr>
                  <a:xfrm>
                    <a:off x="3378615" y="1903979"/>
                    <a:ext cx="755996" cy="291243"/>
                    <a:chOff x="1270030" y="2816023"/>
                    <a:chExt cx="755996" cy="291243"/>
                  </a:xfrm>
                </p:grpSpPr>
                <p:sp>
                  <p:nvSpPr>
                    <p:cNvPr id="206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1BFDA30-BF03-934F-85EF-6493B38D48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52503" y="2844797"/>
                      <a:ext cx="218174" cy="12311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8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3</a:t>
                      </a:r>
                    </a:p>
                  </p:txBody>
                </p:sp>
                <p:sp>
                  <p:nvSpPr>
                    <p:cNvPr id="207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92CCFCF-90B0-334B-982A-4392F24303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502427" y="2968767"/>
                      <a:ext cx="318327" cy="13849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598)</a:t>
                      </a:r>
                    </a:p>
                  </p:txBody>
                </p:sp>
                <p:cxnSp>
                  <p:nvCxnSpPr>
                    <p:cNvPr id="208" name="Connecteur droit 20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580F385-F145-D24A-B082-370C60510A2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270030" y="2816023"/>
                      <a:ext cx="755996" cy="0"/>
                    </a:xfrm>
                    <a:prstGeom prst="line">
                      <a:avLst/>
                    </a:prstGeom>
                    <a:ln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10" name="ZoneTexte 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3FB91A-18A8-AD4F-9214-A76DD0BC2D3E}"/>
                    </a:ext>
                  </a:extLst>
                </p:cNvPr>
                <p:cNvSpPr txBox="1"/>
                <p:nvPr/>
              </p:nvSpPr>
              <p:spPr>
                <a:xfrm>
                  <a:off x="507860" y="787449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/>
                      <a:cs typeface="Arial"/>
                    </a:rPr>
                    <a:t>A</a:t>
                  </a:r>
                </a:p>
              </p:txBody>
            </p:sp>
          </p:grpSp>
          <p:grpSp>
            <p:nvGrpSpPr>
              <p:cNvPr id="13" name="Groupe 12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A7ECA22-07F3-D84F-A173-44692BFD441E}"/>
                  </a:ext>
                </a:extLst>
              </p:cNvPr>
              <p:cNvGrpSpPr/>
              <p:nvPr/>
            </p:nvGrpSpPr>
            <p:grpSpPr>
              <a:xfrm>
                <a:off x="507860" y="2040609"/>
                <a:ext cx="5839257" cy="2484728"/>
                <a:chOff x="507860" y="2151449"/>
                <a:chExt cx="5839257" cy="2484728"/>
              </a:xfrm>
            </p:grpSpPr>
            <p:grpSp>
              <p:nvGrpSpPr>
                <p:cNvPr id="7" name="Groupe 6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9CC760C-B61F-8A48-AE4D-D9228C278D40}"/>
                    </a:ext>
                  </a:extLst>
                </p:cNvPr>
                <p:cNvGrpSpPr/>
                <p:nvPr/>
              </p:nvGrpSpPr>
              <p:grpSpPr>
                <a:xfrm>
                  <a:off x="585252" y="2419235"/>
                  <a:ext cx="5761865" cy="2216942"/>
                  <a:chOff x="480171" y="2597035"/>
                  <a:chExt cx="5761865" cy="2216942"/>
                </a:xfrm>
              </p:grpSpPr>
              <p:grpSp>
                <p:nvGrpSpPr>
                  <p:cNvPr id="5" name="Groupe 4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530FD35-DE59-E04C-B191-20FF4995453A}"/>
                      </a:ext>
                    </a:extLst>
                  </p:cNvPr>
                  <p:cNvGrpSpPr/>
                  <p:nvPr/>
                </p:nvGrpSpPr>
                <p:grpSpPr>
                  <a:xfrm>
                    <a:off x="480171" y="2597035"/>
                    <a:ext cx="1723764" cy="2168281"/>
                    <a:chOff x="289671" y="2597035"/>
                    <a:chExt cx="1723764" cy="2168281"/>
                  </a:xfrm>
                </p:grpSpPr>
                <p:sp>
                  <p:nvSpPr>
                    <p:cNvPr id="21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BA643FC-082E-5346-A2BC-552A40A491C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68016" y="3165715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13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7C209B0-D054-754F-AB63-B8A0A3431DA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1720" y="2597035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350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214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FB5292-3B4B-E148-B386-F67A86F3A42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13395" y="3024345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15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90317E-E622-C442-916B-0F3F2E10067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77210" y="3165715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  <p:sp>
                  <p:nvSpPr>
                    <p:cNvPr id="216" name="Parenthèse ouvrante 2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16EA247-C36F-FF47-B822-AFBD9F69146F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528033" y="2544281"/>
                      <a:ext cx="45719" cy="925085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2" name="Groupe 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6100B14-BCAD-A344-97A3-A276530CFFBE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89671" y="3812665"/>
                      <a:ext cx="474735" cy="906741"/>
                      <a:chOff x="289671" y="3304669"/>
                      <a:chExt cx="474735" cy="906741"/>
                    </a:xfrm>
                  </p:grpSpPr>
                  <p:cxnSp>
                    <p:nvCxnSpPr>
                      <p:cNvPr id="86" name="Connecteur droit avec flèche 8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C18771F-35E3-664E-AB0D-4345B4207AD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56406" y="3934206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4" name="Rectangle 9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673C1BF-121E-2248-92A7-A5AD02FAD44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8525" y="3818183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4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84" name="Connecteur droit avec flèche 8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FB06D35-CD4A-174C-96AE-99F70D4F2F1D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56406" y="3797316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5" name="Rectangle 9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82545AF-F3B3-964F-95D3-07CCC6C9E47A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8525" y="3691761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6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87" name="Connecteur droit avec flèche 8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7E62717-69F5-2741-AA90-0C8000D880F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56406" y="368412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6" name="Rectangle 9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B729508-A379-9E4F-B47A-1BDA2AC3DF81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8525" y="356067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8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  <p:sp>
                    <p:nvSpPr>
                      <p:cNvPr id="97" name="Rectangle 9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1A10FD5-51EA-D741-9209-43111B37434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9671" y="3446809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0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  <p:grpSp>
                    <p:nvGrpSpPr>
                      <p:cNvPr id="106" name="Groupe 10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0EC03EF-A2A4-FD4F-A03F-EA8D841BDDC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26495" y="3569825"/>
                        <a:ext cx="137911" cy="49020"/>
                        <a:chOff x="311886" y="3665448"/>
                        <a:chExt cx="137911" cy="49020"/>
                      </a:xfrm>
                    </p:grpSpPr>
                    <p:cxnSp>
                      <p:nvCxnSpPr>
                        <p:cNvPr id="88" name="Connecteur droit avec flèche 8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02FCE7C-2BA0-5D44-A50F-63B8C15D6AC1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>
                          <a:off x="341797" y="3711293"/>
                          <a:ext cx="108000" cy="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98" name="Connecteur droit avec flèche 97">
                          <a:extLst>
                            <a:ext uri="{FF2B5EF4-FFF2-40B4-BE49-F238E27FC236}">
  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40D480A-8B57-1249-921F-A2D1605FCFF7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311886" y="3665448"/>
                          <a:ext cx="36000" cy="49020"/>
                        </a:xfrm>
                        <a:prstGeom prst="straightConnector1">
                          <a:avLst/>
                        </a:prstGeom>
                        <a:ln>
                          <a:solidFill>
                            <a:schemeClr val="tx1"/>
                          </a:solidFill>
                          <a:headEnd type="none"/>
                          <a:tailEnd type="none"/>
                        </a:ln>
                        <a:effectLst/>
                      </p:spPr>
                      <p:style>
                        <a:lnRef idx="2">
                          <a:schemeClr val="accent1"/>
                        </a:lnRef>
                        <a:fillRef idx="0">
                          <a:schemeClr val="accent1"/>
                        </a:fillRef>
                        <a:effectRef idx="1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89" name="Connecteur droit avec flèche 88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182CF50-2AAC-0C44-8F96-7C53A9169A7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56406" y="3423906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0" name="Rectangle 9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A6EFF0-1F32-6A4D-B22F-C0030D204134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289671" y="3304669"/>
                        <a:ext cx="415498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15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  <p:cxnSp>
                    <p:nvCxnSpPr>
                      <p:cNvPr id="230" name="Connecteur droit avec flèche 229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A5C95CC-D2B7-4442-A026-DC38BFD99F3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656406" y="4111989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231" name="Rectangle 230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09D15A2-9848-9544-956D-2EB245F88D0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18525" y="3995966"/>
                        <a:ext cx="357790" cy="21544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sz="800" dirty="0">
                            <a:solidFill>
                              <a:srgbClr val="000000"/>
                            </a:solidFill>
                            <a:latin typeface="Arial"/>
                            <a:cs typeface="Arial"/>
                          </a:rPr>
                          <a:t>200</a:t>
                        </a:r>
                        <a:endParaRPr lang="fr-FR" sz="800" dirty="0">
                          <a:latin typeface="Arial"/>
                          <a:cs typeface="Arial"/>
                        </a:endParaRPr>
                      </a:p>
                    </p:txBody>
                  </p:sp>
                </p:grpSp>
                <p:pic>
                  <p:nvPicPr>
                    <p:cNvPr id="209" name="Image 20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7E44543-6F1C-784E-B8B5-9C19096BAD01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 rotWithShape="1">
                    <a:blip r:embed="rId2">
                      <a:extLst>
                        <a:ext uri="{28A0092B-C50C-407E-A947-70E740481C1C}">
    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    </a:ext>
                      </a:extLst>
                    </a:blip>
                    <a:srcRect l="17091" t="29844" r="63235" b="26043"/>
                    <a:stretch/>
                  </p:blipFill>
                  <p:spPr bwMode="auto">
                    <a:xfrm>
                      <a:off x="733101" y="3325316"/>
                      <a:ext cx="1260000" cy="1440000"/>
                    </a:xfrm>
                    <a:prstGeom prst="rect">
                      <a:avLst/>
                    </a:prstGeom>
                    <a:ln>
                      <a:noFill/>
                    </a:ln>
                    <a:extLst>
                      <a:ext uri="{53640926-AAD7-44d8-BBD7-CCE9431645EC}">
                        <a14:shadowObscured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="" xmlns:mv="urn:schemas-microsoft-com:mac:vml" xmlns:mc="http://schemas.openxmlformats.org/markup-compatibility/2006"/>
                      </a:ext>
                    </a:extLst>
                  </p:spPr>
                </p:pic>
              </p:grpSp>
              <p:grpSp>
                <p:nvGrpSpPr>
                  <p:cNvPr id="4" name="Groupe 3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F8CEA38-ED25-5347-96A8-FDE832901F81}"/>
                      </a:ext>
                    </a:extLst>
                  </p:cNvPr>
                  <p:cNvGrpSpPr/>
                  <p:nvPr/>
                </p:nvGrpSpPr>
                <p:grpSpPr>
                  <a:xfrm>
                    <a:off x="2521126" y="2597035"/>
                    <a:ext cx="1696966" cy="2163471"/>
                    <a:chOff x="2216326" y="2597035"/>
                    <a:chExt cx="1696966" cy="2163471"/>
                  </a:xfrm>
                </p:grpSpPr>
                <p:sp>
                  <p:nvSpPr>
                    <p:cNvPr id="237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40D7ED-53B0-314E-A803-92831972FF0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39224" y="3161173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38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225F8BF-1602-B245-ABEF-4437C44B55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042928" y="2597035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265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239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551B0EE-7112-9A40-92C2-33A6930614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84603" y="3019803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40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DAA4DB-4CC7-864B-807B-08CFAE2FBEE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548418" y="3161173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  <p:sp>
                  <p:nvSpPr>
                    <p:cNvPr id="241" name="Parenthèse ouvrante 24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59D755-FF13-0346-AAD3-27A56DA14FC2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3399241" y="2544281"/>
                      <a:ext cx="45719" cy="925085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43" name="Connecteur droit avec flèche 24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58D6B9B-4B57-EA49-9FA7-6325ADBC0E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83061" y="442905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4" name="Rectangle 24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49E4DA7-B3D1-A644-961D-C93E94C0235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45180" y="4313028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45" name="Connecteur droit avec flèche 24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E263F1D-8F43-6D4C-B36C-DA40F3DB798C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83061" y="4292161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6" name="Rectangle 24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2B73D5C-89CB-3942-9591-FC799D16468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45180" y="4186606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47" name="Connecteur droit avec flèche 24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77223C6-E096-8349-ACCA-5DC574A0708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83061" y="4208848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48" name="Rectangle 24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FCB06F1-2702-6247-AE60-832498371AF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45180" y="4085401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49" name="Rectangle 24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7EC945F-93E9-DD4F-B21C-433DF257057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16326" y="3941654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250" name="Groupe 24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50D869E-0CAE-0F48-84DB-E3CEF1B7BAF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553150" y="4064670"/>
                      <a:ext cx="137911" cy="49020"/>
                      <a:chOff x="311886" y="3665448"/>
                      <a:chExt cx="137911" cy="49020"/>
                    </a:xfrm>
                  </p:grpSpPr>
                  <p:cxnSp>
                    <p:nvCxnSpPr>
                      <p:cNvPr id="255" name="Connecteur droit avec flèche 25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2CDB141-7B19-8D4E-92F9-DB66D2301697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56" name="Connecteur droit avec flèche 25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8D76514-53DD-5A4F-95D0-FF90866E2FA4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11886" y="3665448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251" name="Connecteur droit avec flèche 25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083F67A-6163-014E-A6B6-30DC5D44CFB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83061" y="3954607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2" name="Rectangle 25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A580BE6-FD86-F846-BA6F-F9E957FA560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16326" y="3835370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53" name="Connecteur droit avec flèche 25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E344238-990F-B646-BCDE-D7F69F6E006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2583061" y="4606834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4" name="Rectangle 25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5B08F5F-0AEE-3942-A12D-77B4F9AB3AE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245180" y="4490811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pic>
                  <p:nvPicPr>
                    <p:cNvPr id="210" name="Image 20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4068C2E-A320-584D-A658-EE360FD19CC2}"/>
                        </a:ext>
                      </a:extLst>
                    </p:cNvPr>
                    <p:cNvPicPr preferRelativeResize="0">
                      <a:picLocks/>
                    </p:cNvPicPr>
                    <p:nvPr/>
                  </p:nvPicPr>
                  <p:blipFill>
                    <a:blip r:embed="rId3">
                      <a:extLst>
                        <a:ext uri="{28A0092B-C50C-407E-A947-70E740481C1C}">
    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653292" y="3320506"/>
                      <a:ext cx="1260000" cy="1440000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3" name="Groupe 2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4CC2B1-A16E-EA44-B682-0D4B05705719}"/>
                      </a:ext>
                    </a:extLst>
                  </p:cNvPr>
                  <p:cNvGrpSpPr/>
                  <p:nvPr/>
                </p:nvGrpSpPr>
                <p:grpSpPr>
                  <a:xfrm>
                    <a:off x="4544897" y="2597035"/>
                    <a:ext cx="1697139" cy="2216942"/>
                    <a:chOff x="4100397" y="2597035"/>
                    <a:chExt cx="1697139" cy="2216942"/>
                  </a:xfrm>
                </p:grpSpPr>
                <p:cxnSp>
                  <p:nvCxnSpPr>
                    <p:cNvPr id="257" name="Connecteur droit avec flèche 25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0A5B032-E32E-3642-A8E7-5FEC1813929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67132" y="4536773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8" name="Rectangle 25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0BD85F1-F555-DE48-B4BB-D7447CE15D35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29251" y="4420750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59" name="Connecteur droit avec flèche 25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D16FB80-73C5-7945-AE7F-106270DF2B5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67132" y="4370003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0" name="Rectangle 25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F244298F-0787-C345-9C1E-04293ADC37F2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29251" y="4264448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6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61" name="Connecteur droit avec flèche 260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D47B857-1E6A-7B4A-8F5A-6E305903F022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67132" y="4238878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2" name="Rectangle 261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96B8009-7A77-D648-8E05-222582563E0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29251" y="4115431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8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63" name="Rectangle 26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AB959C9-FCCC-794D-B801-3111F6466A4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00397" y="3983640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0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264" name="Groupe 263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9140E5A-2AD4-B84A-B8BD-7BE1C692CCB2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437221" y="4106656"/>
                      <a:ext cx="137911" cy="49020"/>
                      <a:chOff x="311886" y="3665448"/>
                      <a:chExt cx="137911" cy="49020"/>
                    </a:xfrm>
                  </p:grpSpPr>
                  <p:cxnSp>
                    <p:nvCxnSpPr>
                      <p:cNvPr id="265" name="Connecteur droit avec flèche 26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DEA2A8C-1028-614A-B4D3-3C2DCF9AE6EE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341797" y="3711293"/>
                        <a:ext cx="108000" cy="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66" name="Connecteur droit avec flèche 26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BC81236-693C-8E40-ADCA-D7A146CD871A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 flipV="1">
                        <a:off x="311886" y="3665448"/>
                        <a:ext cx="36000" cy="49020"/>
                      </a:xfrm>
                      <a:prstGeom prst="straightConnector1">
                        <a:avLst/>
                      </a:prstGeom>
                      <a:ln>
                        <a:solidFill>
                          <a:schemeClr val="tx1"/>
                        </a:solidFill>
                        <a:headEnd type="none"/>
                        <a:tailEnd type="none"/>
                      </a:ln>
                      <a:effectLst/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267" name="Connecteur droit avec flèche 26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422AEC2-E017-2043-8052-75FC1BB33FEA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67132" y="3960732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68" name="Rectangle 267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FFA8006-FDAF-D946-8A40-B877F7E4A0E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00397" y="3841495"/>
                      <a:ext cx="415498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5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cxnSp>
                  <p:nvCxnSpPr>
                    <p:cNvPr id="269" name="Connecteur droit avec flèche 26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F3EECA0-86D2-4745-9DBE-C96CD79BE967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>
                      <a:off x="4467132" y="4714556"/>
                      <a:ext cx="108000" cy="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headEnd type="none"/>
                      <a:tailEnd type="none"/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70" name="Rectangle 26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5C4351E-DBC8-684C-A79B-E6DBE8718FD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129251" y="4598533"/>
                      <a:ext cx="357790" cy="215444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800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00</a:t>
                      </a:r>
                      <a:endParaRPr lang="fr-FR" sz="800" dirty="0">
                        <a:latin typeface="Arial"/>
                        <a:cs typeface="Arial"/>
                      </a:endParaRPr>
                    </a:p>
                  </p:txBody>
                </p:sp>
                <p:pic>
                  <p:nvPicPr>
                    <p:cNvPr id="211" name="Image 210" descr="D:\Gel\GelDocXRPlus 2018-12-04 14hr 13min.jpg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2E3CB4E-75B2-D645-A96E-5A1A7435139E}"/>
                        </a:ext>
                      </a:extLst>
                    </p:cNvPr>
                    <p:cNvPicPr>
                      <a:picLocks/>
                    </p:cNvPicPr>
                    <p:nvPr/>
                  </p:nvPicPr>
                  <p:blipFill rotWithShape="1">
                    <a:blip r:embed="rId4">
                      <a:extLst>
                        <a:ext uri="{28A0092B-C50C-407E-A947-70E740481C1C}">
                          <a14:useLocalDpi xmlns=""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:mv="urn:schemas-microsoft-com:mac:vml" xmlns:mc="http://schemas.openxmlformats.org/markup-compatibility/2006" val="0"/>
                        </a:ext>
                      </a:extLst>
                    </a:blip>
                    <a:srcRect l="3834" t="36213" r="78000" b="6459"/>
                    <a:stretch/>
                  </p:blipFill>
                  <p:spPr bwMode="auto">
                    <a:xfrm>
                      <a:off x="4518078" y="3320506"/>
                      <a:ext cx="1260000" cy="14400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53640926-AAD7-44d8-BBD7-CCE9431645EC}">
                        <a14:shadowObscured xmlns:a="http://schemas.openxmlformats.org/drawingml/2006/main" xmlns:r="http://schemas.openxmlformats.org/officeDocument/2006/relationships" xmlns:p="http://schemas.openxmlformats.org/presentationml/2006/main" xmlns:a14="http://schemas.microsoft.com/office/drawing/2010/main" xmlns="" xmlns:mv="urn:schemas-microsoft-com:mac:vml" xmlns:mc="http://schemas.openxmlformats.org/markup-compatibility/2006"/>
                      </a:ext>
                    </a:extLst>
                  </p:spPr>
                </p:pic>
                <p:sp>
                  <p:nvSpPr>
                    <p:cNvPr id="271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460EA688-3F09-1446-ACF4-ADBD06BBCFA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52117" y="3168091"/>
                      <a:ext cx="417823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g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72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8AA88BB-4F13-FE46-AFEB-FCA5AE43A8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14136" y="2597035"/>
                      <a:ext cx="84171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3</a:t>
                      </a:r>
                    </a:p>
                    <a:p>
                      <a:pPr algn="ctr"/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(598 </a:t>
                      </a:r>
                      <a:r>
                        <a:rPr lang="en-US" sz="12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bp</a:t>
                      </a:r>
                      <a:r>
                        <a:rPr lang="en-US" sz="12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)</a:t>
                      </a:r>
                    </a:p>
                  </p:txBody>
                </p:sp>
                <p:sp>
                  <p:nvSpPr>
                    <p:cNvPr id="273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8B9F4CB5-E853-9248-91C2-008586DC461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197496" y="3026721"/>
                      <a:ext cx="391930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 err="1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DNA</a:t>
                      </a:r>
                      <a:endParaRPr lang="en-US" sz="10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p:txBody>
                </p:sp>
                <p:sp>
                  <p:nvSpPr>
                    <p:cNvPr id="274" name="TextBox 2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F94A1CD-B4F0-AA47-9F0A-5CE57B3AFED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61311" y="3168091"/>
                      <a:ext cx="299285" cy="153888"/>
                    </a:xfrm>
                    <a:prstGeom prst="rect">
                      <a:avLst/>
                    </a:prstGeom>
                    <a:noFill/>
                  </p:spPr>
                  <p:txBody>
                    <a:bodyPr wrap="square" lIns="0" tIns="0" rIns="0" bIns="0" rtlCol="0">
                      <a:spAutoFit/>
                    </a:bodyPr>
                    <a:lstStyle/>
                    <a:p>
                      <a:pPr algn="ctr"/>
                      <a:r>
                        <a:rPr lang="en-US" sz="1000" b="1" dirty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NA</a:t>
                      </a:r>
                    </a:p>
                  </p:txBody>
                </p:sp>
                <p:sp>
                  <p:nvSpPr>
                    <p:cNvPr id="275" name="Parenthèse ouvrante 27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0DFB79FB-ACC8-724E-9058-231FB6D8A8E6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5312134" y="2544281"/>
                      <a:ext cx="45719" cy="925085"/>
                    </a:xfrm>
                    <a:prstGeom prst="leftBracket">
                      <a:avLst/>
                    </a:prstGeom>
                    <a:ln w="1905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  <p:sp>
              <p:nvSpPr>
                <p:cNvPr id="108" name="ZoneTexte 107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B992F1EC-5A8F-324E-82B7-F758A437CD6C}"/>
                    </a:ext>
                  </a:extLst>
                </p:cNvPr>
                <p:cNvSpPr txBox="1"/>
                <p:nvPr/>
              </p:nvSpPr>
              <p:spPr>
                <a:xfrm>
                  <a:off x="507860" y="2151449"/>
                  <a:ext cx="332142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/>
                      <a:cs typeface="Arial"/>
                    </a:rPr>
                    <a:t>B</a:t>
                  </a:r>
                </a:p>
              </p:txBody>
            </p:sp>
          </p:grpSp>
          <p:grpSp>
            <p:nvGrpSpPr>
              <p:cNvPr id="21" name="Groupe 20">
                <a:extLst>
                  <a:ext uri="{FF2B5EF4-FFF2-40B4-BE49-F238E27FC236}">
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9849DCE-498C-EC4B-8C82-784D524174B2}"/>
                  </a:ext>
                </a:extLst>
              </p:cNvPr>
              <p:cNvGrpSpPr/>
              <p:nvPr/>
            </p:nvGrpSpPr>
            <p:grpSpPr>
              <a:xfrm>
                <a:off x="507860" y="4854204"/>
                <a:ext cx="5062921" cy="2962341"/>
                <a:chOff x="507860" y="5159006"/>
                <a:chExt cx="5062921" cy="2962341"/>
              </a:xfrm>
            </p:grpSpPr>
            <p:sp>
              <p:nvSpPr>
                <p:cNvPr id="109" name="ZoneTexte 108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9C2321-505A-9F4E-B9B9-A8751BEE2369}"/>
                    </a:ext>
                  </a:extLst>
                </p:cNvPr>
                <p:cNvSpPr txBox="1"/>
                <p:nvPr/>
              </p:nvSpPr>
              <p:spPr>
                <a:xfrm>
                  <a:off x="507860" y="5159006"/>
                  <a:ext cx="33214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fr-FR" sz="1600" b="1" dirty="0">
                      <a:latin typeface="Arial"/>
                      <a:cs typeface="Arial"/>
                    </a:rPr>
                    <a:t>C</a:t>
                  </a:r>
                </a:p>
              </p:txBody>
            </p:sp>
            <p:grpSp>
              <p:nvGrpSpPr>
                <p:cNvPr id="20" name="Groupe 19">
                  <a:extLst>
                    <a:ext uri="{FF2B5EF4-FFF2-40B4-BE49-F238E27FC236}">
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617DB865-CB66-E741-8F8D-108FF5AC2DED}"/>
                    </a:ext>
                  </a:extLst>
                </p:cNvPr>
                <p:cNvGrpSpPr/>
                <p:nvPr/>
              </p:nvGrpSpPr>
              <p:grpSpPr>
                <a:xfrm>
                  <a:off x="1363597" y="5343672"/>
                  <a:ext cx="4207184" cy="2777675"/>
                  <a:chOff x="1363597" y="5343672"/>
                  <a:chExt cx="4207184" cy="2777675"/>
                </a:xfrm>
              </p:grpSpPr>
              <p:sp>
                <p:nvSpPr>
                  <p:cNvPr id="281" name="ZoneTexte 280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A5A05D2C-8DE5-CE47-B6F4-FF8AF2B3DA07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627285" y="6360234"/>
                    <a:ext cx="1749623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200" b="1" dirty="0">
                        <a:latin typeface="Arial"/>
                        <a:cs typeface="Arial"/>
                      </a:rPr>
                      <a:t>Gene expression </a:t>
                    </a:r>
                    <a:r>
                      <a:rPr lang="fr-FR" sz="1200" b="1" dirty="0" err="1">
                        <a:latin typeface="Arial"/>
                        <a:cs typeface="Arial"/>
                      </a:rPr>
                      <a:t>fold</a:t>
                    </a:r>
                    <a:endParaRPr lang="fr-FR" sz="12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82" name="ZoneTexte 281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2B020D69-ABF5-DE48-8954-119BF2C3C5EF}"/>
                      </a:ext>
                    </a:extLst>
                  </p:cNvPr>
                  <p:cNvSpPr txBox="1"/>
                  <p:nvPr/>
                </p:nvSpPr>
                <p:spPr>
                  <a:xfrm>
                    <a:off x="4700030" y="7478296"/>
                    <a:ext cx="87075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fr-FR" sz="1000" b="1" dirty="0">
                        <a:latin typeface="Arial"/>
                        <a:cs typeface="Arial"/>
                      </a:rPr>
                      <a:t>10 </a:t>
                    </a:r>
                    <a:r>
                      <a:rPr lang="fr-FR" sz="1000" b="1" dirty="0" err="1">
                        <a:latin typeface="Arial"/>
                        <a:cs typeface="Arial"/>
                      </a:rPr>
                      <a:t>μM</a:t>
                    </a:r>
                    <a:r>
                      <a:rPr lang="fr-FR" sz="1000" b="1" dirty="0">
                        <a:latin typeface="Arial"/>
                        <a:cs typeface="Arial"/>
                      </a:rPr>
                      <a:t> H</a:t>
                    </a:r>
                    <a:r>
                      <a:rPr lang="fr-FR" sz="1000" b="1" baseline="-25000" dirty="0">
                        <a:latin typeface="Arial"/>
                        <a:cs typeface="Arial"/>
                      </a:rPr>
                      <a:t>2</a:t>
                    </a:r>
                    <a:r>
                      <a:rPr lang="fr-FR" sz="1000" b="1" dirty="0">
                        <a:latin typeface="Arial"/>
                        <a:cs typeface="Arial"/>
                      </a:rPr>
                      <a:t>O</a:t>
                    </a:r>
                    <a:r>
                      <a:rPr lang="fr-FR" sz="1000" b="1" baseline="-25000" dirty="0">
                        <a:latin typeface="Arial"/>
                        <a:cs typeface="Arial"/>
                      </a:rPr>
                      <a:t>2</a:t>
                    </a:r>
                  </a:p>
                </p:txBody>
              </p:sp>
              <p:pic>
                <p:nvPicPr>
                  <p:cNvPr id="9" name="Image 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3AF8D36-395B-1646-88F1-FB5F0EB29A9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749835" y="5343672"/>
                    <a:ext cx="3118583" cy="2124749"/>
                  </a:xfrm>
                  <a:prstGeom prst="rect">
                    <a:avLst/>
                  </a:prstGeom>
                </p:spPr>
              </p:pic>
              <p:grpSp>
                <p:nvGrpSpPr>
                  <p:cNvPr id="19" name="Groupe 18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AFE3478-FFE8-1344-9ABC-7F40D4AF1998}"/>
                      </a:ext>
                    </a:extLst>
                  </p:cNvPr>
                  <p:cNvGrpSpPr/>
                  <p:nvPr/>
                </p:nvGrpSpPr>
                <p:grpSpPr>
                  <a:xfrm>
                    <a:off x="2013199" y="7412078"/>
                    <a:ext cx="1226618" cy="709269"/>
                    <a:chOff x="2013199" y="7412078"/>
                    <a:chExt cx="1226618" cy="709269"/>
                  </a:xfrm>
                </p:grpSpPr>
                <p:sp>
                  <p:nvSpPr>
                    <p:cNvPr id="279" name="ZoneTexte 278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B972881-ED6E-DF44-9B45-4B1DEF0D21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13199" y="7721237"/>
                      <a:ext cx="1226618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000" b="1" dirty="0">
                          <a:latin typeface="Arial"/>
                          <a:cs typeface="Arial"/>
                        </a:rPr>
                        <a:t>LIMLP_18595</a:t>
                      </a:r>
                    </a:p>
                    <a:p>
                      <a:pPr algn="ctr"/>
                      <a:r>
                        <a:rPr lang="fr-FR" sz="1000" b="1" dirty="0" err="1">
                          <a:latin typeface="Arial"/>
                          <a:cs typeface="Arial"/>
                        </a:rPr>
                        <a:t>Heme</a:t>
                      </a:r>
                      <a:r>
                        <a:rPr lang="fr-FR" sz="1000" b="1" dirty="0">
                          <a:latin typeface="Arial"/>
                          <a:cs typeface="Arial"/>
                        </a:rPr>
                        <a:t> </a:t>
                      </a:r>
                      <a:r>
                        <a:rPr lang="fr-FR" sz="1000" b="1" dirty="0" err="1">
                          <a:latin typeface="Arial"/>
                          <a:cs typeface="Arial"/>
                        </a:rPr>
                        <a:t>oxygenase</a:t>
                      </a:r>
                      <a:endParaRPr lang="fr-FR" sz="1000" b="1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16" name="Groupe 15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7A657EBB-1D5C-754D-B179-B2A5FAC8319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106080" y="7412078"/>
                      <a:ext cx="1077043" cy="307777"/>
                      <a:chOff x="2106080" y="7412078"/>
                      <a:chExt cx="1077043" cy="307777"/>
                    </a:xfrm>
                  </p:grpSpPr>
                  <p:sp>
                    <p:nvSpPr>
                      <p:cNvPr id="283" name="ZoneTexte 282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8780E32-57BD-4542-AB88-EF2E7D1C0CB2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106080" y="7412078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284" name="ZoneTexte 283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5AB7697-A105-3E49-B13A-07206960420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493043" y="7412078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287" name="ZoneTexte 286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B80D6E-D1D8-484D-87B6-35461B76FD9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893611" y="7412078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113" name="Parenthèse ouvrante 112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AD475E2-9817-EA48-B8D9-30333367CCF5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2591787" y="7053608"/>
                      <a:ext cx="99307" cy="1188000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</p:grpSp>
              <p:grpSp>
                <p:nvGrpSpPr>
                  <p:cNvPr id="18" name="Groupe 17">
                    <a:extLst>
                      <a:ext uri="{FF2B5EF4-FFF2-40B4-BE49-F238E27FC236}">
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C2645AFE-71EC-2345-AB35-B1B0B8788261}"/>
                      </a:ext>
                    </a:extLst>
                  </p:cNvPr>
                  <p:cNvGrpSpPr/>
                  <p:nvPr/>
                </p:nvGrpSpPr>
                <p:grpSpPr>
                  <a:xfrm>
                    <a:off x="3513942" y="7412078"/>
                    <a:ext cx="1188000" cy="709269"/>
                    <a:chOff x="3513942" y="7412078"/>
                    <a:chExt cx="1188000" cy="709269"/>
                  </a:xfrm>
                </p:grpSpPr>
                <p:sp>
                  <p:nvSpPr>
                    <p:cNvPr id="280" name="ZoneTexte 279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D136FE28-E444-B241-902C-6600692751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603859" y="7721237"/>
                      <a:ext cx="992579" cy="40011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fr-FR" sz="1000" b="1" dirty="0">
                          <a:latin typeface="Arial"/>
                          <a:cs typeface="Arial"/>
                        </a:rPr>
                        <a:t>LIMLP_18600</a:t>
                      </a:r>
                    </a:p>
                    <a:p>
                      <a:pPr algn="ctr"/>
                      <a:r>
                        <a:rPr lang="fr-FR" sz="1000" b="1" dirty="0" err="1">
                          <a:latin typeface="Arial"/>
                          <a:cs typeface="Arial"/>
                        </a:rPr>
                        <a:t>Permease</a:t>
                      </a:r>
                      <a:endParaRPr lang="fr-FR" sz="1000" b="1" dirty="0">
                        <a:latin typeface="Arial"/>
                        <a:cs typeface="Arial"/>
                      </a:endParaRPr>
                    </a:p>
                  </p:txBody>
                </p:sp>
                <p:grpSp>
                  <p:nvGrpSpPr>
                    <p:cNvPr id="17" name="Groupe 16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5F4B128A-69FA-984E-882F-DDF20C8EEF9B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583880" y="7412078"/>
                      <a:ext cx="1063641" cy="307777"/>
                      <a:chOff x="3583880" y="7412078"/>
                      <a:chExt cx="1063641" cy="307777"/>
                    </a:xfrm>
                  </p:grpSpPr>
                  <p:sp>
                    <p:nvSpPr>
                      <p:cNvPr id="285" name="ZoneTexte 284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E71FC3B6-B42E-8943-9BE8-A810C24D1A4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583880" y="7412078"/>
                        <a:ext cx="248786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-</a:t>
                        </a:r>
                      </a:p>
                    </p:txBody>
                  </p:sp>
                  <p:sp>
                    <p:nvSpPr>
                      <p:cNvPr id="286" name="ZoneTexte 285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360802B3-2BAA-6045-AE3D-47145B7FACC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57521" y="7412078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  <p:sp>
                    <p:nvSpPr>
                      <p:cNvPr id="288" name="ZoneTexte 287">
                        <a:extLst>
                          <a:ext uri="{FF2B5EF4-FFF2-40B4-BE49-F238E27FC236}">
  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9CA6FD25-0D0D-D946-942D-65C02154B5C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358009" y="7412078"/>
                        <a:ext cx="289512" cy="30777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400" b="1" dirty="0">
                            <a:latin typeface="Arial"/>
                            <a:cs typeface="Arial"/>
                          </a:rPr>
                          <a:t>+</a:t>
                        </a:r>
                      </a:p>
                    </p:txBody>
                  </p:sp>
                </p:grpSp>
                <p:sp>
                  <p:nvSpPr>
                    <p:cNvPr id="115" name="Parenthèse ouvrante 114">
                      <a:extLst>
                        <a:ext uri="{FF2B5EF4-FFF2-40B4-BE49-F238E27FC236}">
        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6578AF4-F634-9C42-8AC0-140770CCD427}"/>
                        </a:ext>
                      </a:extLst>
                    </p:cNvPr>
                    <p:cNvSpPr/>
                    <p:nvPr/>
                  </p:nvSpPr>
                  <p:spPr>
                    <a:xfrm rot="16200000">
                      <a:off x="4058288" y="7053608"/>
                      <a:ext cx="99307" cy="1188000"/>
                    </a:xfrm>
                    <a:prstGeom prst="leftBracket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fr-FR">
                        <a:latin typeface="Arial"/>
                        <a:cs typeface="Arial"/>
                      </a:endParaRPr>
                    </a:p>
                  </p:txBody>
                </p:sp>
              </p:grpSp>
            </p:grpSp>
          </p:grpSp>
        </p:grpSp>
        <p:sp>
          <p:nvSpPr>
            <p:cNvPr id="122" name="ZoneTexte 121">
              <a:extLst>
                <a:ext uri="{FF2B5EF4-FFF2-40B4-BE49-F238E27FC236}">
                  <a16:creationId xmlns="" xmlns:a="http://schemas.openxmlformats.org/drawingml/2006/main" xmlns:r="http://schemas.openxmlformats.org/officeDocument/2006/relationships" xmlns:p="http://schemas.openxmlformats.org/presentationml/2006/main" xmlns:a16="http://schemas.microsoft.com/office/drawing/2014/main" xmlns:mv="urn:schemas-microsoft-com:mac:vml" xmlns:mc="http://schemas.openxmlformats.org/markup-compatibility/2006" id="{1F4E7601-D333-6643-A856-3BFA7D242383}"/>
                </a:ext>
              </a:extLst>
            </p:cNvPr>
            <p:cNvSpPr txBox="1"/>
            <p:nvPr/>
          </p:nvSpPr>
          <p:spPr>
            <a:xfrm>
              <a:off x="151486" y="8289657"/>
              <a:ext cx="65277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b="1" dirty="0">
                  <a:latin typeface="Arial"/>
                  <a:cs typeface="Arial"/>
                </a:rPr>
                <a:t>S4 Fig. </a:t>
              </a:r>
              <a:r>
                <a:rPr lang="en-GB" sz="1000" b="1" dirty="0">
                  <a:latin typeface="Arial"/>
                  <a:cs typeface="Arial"/>
                </a:rPr>
                <a:t>Increase of the the </a:t>
              </a:r>
              <a:r>
                <a:rPr lang="en-US" sz="1000" b="1" dirty="0">
                  <a:latin typeface="Arial"/>
                  <a:cs typeface="Arial"/>
                </a:rPr>
                <a:t>LIMLP_17860-65 operon expression </a:t>
              </a:r>
              <a:r>
                <a:rPr lang="en-GB" sz="1000" b="1" dirty="0">
                  <a:latin typeface="Arial"/>
                  <a:cs typeface="Arial"/>
                </a:rPr>
                <a:t>upon exposure to sublethal dose of H</a:t>
              </a:r>
              <a:r>
                <a:rPr lang="en-GB" sz="1000" b="1" baseline="-25000" dirty="0">
                  <a:latin typeface="Arial"/>
                  <a:cs typeface="Arial"/>
                </a:rPr>
                <a:t>2</a:t>
              </a:r>
              <a:r>
                <a:rPr lang="en-GB" sz="1000" b="1" dirty="0">
                  <a:latin typeface="Arial"/>
                  <a:cs typeface="Arial"/>
                </a:rPr>
                <a:t>O</a:t>
              </a:r>
              <a:r>
                <a:rPr lang="en-GB" sz="1000" b="1" baseline="-25000" dirty="0">
                  <a:latin typeface="Arial"/>
                  <a:cs typeface="Arial"/>
                </a:rPr>
                <a:t>2</a:t>
              </a:r>
              <a:r>
                <a:rPr lang="en-US" sz="1000" b="1" dirty="0">
                  <a:latin typeface="Arial"/>
                  <a:cs typeface="Arial"/>
                </a:rPr>
                <a:t>.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3753421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103</Words>
  <Application>Microsoft Macintosh PowerPoint</Application>
  <PresentationFormat>Présentation à l'écran (4:3)</PresentationFormat>
  <Paragraphs>64</Paragraphs>
  <Slides>1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nadia benaroudj</cp:lastModifiedBy>
  <cp:revision>12</cp:revision>
  <cp:lastPrinted>2020-03-17T19:45:33Z</cp:lastPrinted>
  <dcterms:created xsi:type="dcterms:W3CDTF">2020-04-03T12:03:14Z</dcterms:created>
  <dcterms:modified xsi:type="dcterms:W3CDTF">2020-04-03T12:04:23Z</dcterms:modified>
</cp:coreProperties>
</file>